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C336-4A81-A9DB-90F353709BEF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C336-4A81-A9DB-90F353709BEF}"/>
              </c:ext>
            </c:extLst>
          </c:dPt>
          <c:dLbls>
            <c:dLbl>
              <c:idx val="0"/>
              <c:layout>
                <c:manualLayout>
                  <c:x val="-3.3193595569098906E-3"/>
                  <c:y val="3.6377559249454128E-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C336-4A81-A9DB-90F353709BEF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baseline="0" dirty="0"/>
                      <a:t>DPA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C336-4A81-A9DB-90F353709BEF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녀_2020_D!$B$1:$B$2</c:f>
              <c:numCache>
                <c:formatCode>General</c:formatCode>
                <c:ptCount val="2"/>
                <c:pt idx="0">
                  <c:v>99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336-4A81-A9DB-90F353709BEF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5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AB88-455B-A7D8-4C228BCC277E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AB88-455B-A7D8-4C228BCC277E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AB88-455B-A7D8-4C228BCC277E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0F94388-9288-4D39-9232-E81D835958E9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AB88-455B-A7D8-4C228BCC277E}"/>
                </c:ext>
              </c:extLst>
            </c:dLbl>
            <c:dLbl>
              <c:idx val="1"/>
              <c:layout>
                <c:manualLayout>
                  <c:x val="3.9303047709431167E-2"/>
                  <c:y val="-8.2719711200008005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B88-455B-A7D8-4C228BCC277E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AB88-455B-A7D8-4C228BCC277E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D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남녀_2020_D!$B$5:$B$7</c:f>
              <c:numCache>
                <c:formatCode>General</c:formatCode>
                <c:ptCount val="3"/>
                <c:pt idx="0">
                  <c:v>639</c:v>
                </c:pt>
                <c:pt idx="1">
                  <c:v>100</c:v>
                </c:pt>
                <c:pt idx="2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B88-455B-A7D8-4C228BCC277E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8503-4481-BD7D-D8A61831F8CF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8503-4481-BD7D-D8A61831F8CF}"/>
              </c:ext>
            </c:extLst>
          </c:dPt>
          <c:dLbls>
            <c:dLbl>
              <c:idx val="0"/>
              <c:layout>
                <c:manualLayout>
                  <c:x val="-3.6150229251468271E-3"/>
                  <c:y val="3.3307659802743368E-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8503-4481-BD7D-D8A61831F8CF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baseline="0" dirty="0"/>
                      <a:t>DPA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8503-4481-BD7D-D8A61831F8CF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자_2020_D!$B$1:$B$2</c:f>
              <c:numCache>
                <c:formatCode>General</c:formatCode>
                <c:ptCount val="2"/>
                <c:pt idx="0">
                  <c:v>99.7</c:v>
                </c:pt>
                <c:pt idx="1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503-4481-BD7D-D8A61831F8CF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2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BFEE-4174-9C38-838FBE0BBC61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4FC9A4F7-34E4-49DA-A358-CFC436E1648B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BFEE-4174-9C38-838FBE0BBC61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D!$A$5</c:f>
              <c:strCache>
                <c:ptCount val="1"/>
                <c:pt idx="0">
                  <c:v>Colorectal</c:v>
                </c:pt>
              </c:strCache>
            </c:strRef>
          </c:cat>
          <c:val>
            <c:numRef>
              <c:f>남자_2020_D!$B$5</c:f>
              <c:numCache>
                <c:formatCode>General</c:formatCode>
                <c:ptCount val="1"/>
                <c:pt idx="0">
                  <c:v>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FEE-4174-9C38-838FBE0BBC61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DB1F-48A1-875C-A94467042CFD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DB1F-48A1-875C-A94467042CFD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B1F-48A1-875C-A94467042CFD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baseline="0" dirty="0"/>
                      <a:t>DPA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B1F-48A1-875C-A94467042CFD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여자_2020_D!$B$1:$B$2</c:f>
              <c:numCache>
                <c:formatCode>General</c:formatCode>
                <c:ptCount val="2"/>
                <c:pt idx="0">
                  <c:v>98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B1F-48A1-875C-A94467042CFD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3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22F3-43D9-BCEF-7CA74969F06C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22F3-43D9-BCEF-7CA74969F06C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22F3-43D9-BCEF-7CA74969F06C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72DE87BD-D998-41D5-A1DB-FCEAE9B5F849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2F3-43D9-BCEF-7CA74969F06C}"/>
                </c:ext>
              </c:extLst>
            </c:dLbl>
            <c:dLbl>
              <c:idx val="1"/>
              <c:layout>
                <c:manualLayout>
                  <c:x val="-2.6501826793594297E-2"/>
                  <c:y val="0.10272760458445165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2F3-43D9-BCEF-7CA74969F06C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2F3-43D9-BCEF-7CA74969F06C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D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여자_2020_D!$B$5:$B$7</c:f>
              <c:numCache>
                <c:formatCode>General</c:formatCode>
                <c:ptCount val="3"/>
                <c:pt idx="0">
                  <c:v>472</c:v>
                </c:pt>
                <c:pt idx="1">
                  <c:v>100</c:v>
                </c:pt>
                <c:pt idx="2">
                  <c:v>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2F3-43D9-BCEF-7CA74969F06C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288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184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7110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35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489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66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27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82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046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655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1322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248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F71CFB14-3AD4-4824-A5C8-F47A235380EF}"/>
              </a:ext>
            </a:extLst>
          </p:cNvPr>
          <p:cNvGrpSpPr/>
          <p:nvPr/>
        </p:nvGrpSpPr>
        <p:grpSpPr>
          <a:xfrm>
            <a:off x="495814" y="321960"/>
            <a:ext cx="5866373" cy="9401619"/>
            <a:chOff x="495814" y="620837"/>
            <a:chExt cx="5866373" cy="9401619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550300" y="9468458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10. The population attributable fraction (%) of cancer deaths attributed to deficit in physical activity (DPA) and proportion of specific cancers among all-cancer deaths caused by DPA in Korea, 2020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D94DDBF5-7856-4284-84CD-CD88498B3302}"/>
                </a:ext>
              </a:extLst>
            </p:cNvPr>
            <p:cNvGrpSpPr/>
            <p:nvPr/>
          </p:nvGrpSpPr>
          <p:grpSpPr>
            <a:xfrm>
              <a:off x="495814" y="620837"/>
              <a:ext cx="5866373" cy="8871471"/>
              <a:chOff x="515254" y="620837"/>
              <a:chExt cx="5866373" cy="8871471"/>
            </a:xfrm>
          </p:grpSpPr>
          <p:grpSp>
            <p:nvGrpSpPr>
              <p:cNvPr id="4" name="그룹 3">
                <a:extLst>
                  <a:ext uri="{FF2B5EF4-FFF2-40B4-BE49-F238E27FC236}">
                    <a16:creationId xmlns:a16="http://schemas.microsoft.com/office/drawing/2014/main" id="{95F28AF6-AB45-4BFE-96B9-66D525048C43}"/>
                  </a:ext>
                </a:extLst>
              </p:cNvPr>
              <p:cNvGrpSpPr/>
              <p:nvPr/>
            </p:nvGrpSpPr>
            <p:grpSpPr>
              <a:xfrm>
                <a:off x="515254" y="620837"/>
                <a:ext cx="5866372" cy="3022191"/>
                <a:chOff x="515254" y="620837"/>
                <a:chExt cx="5866372" cy="3022191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ED0E3951-E7A8-4D37-953A-49C87951C1DC}"/>
                    </a:ext>
                  </a:extLst>
                </p:cNvPr>
                <p:cNvSpPr txBox="1"/>
                <p:nvPr/>
              </p:nvSpPr>
              <p:spPr>
                <a:xfrm>
                  <a:off x="515254" y="620837"/>
                  <a:ext cx="158248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death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0" name="그룹 29">
                  <a:extLst>
                    <a:ext uri="{FF2B5EF4-FFF2-40B4-BE49-F238E27FC236}">
                      <a16:creationId xmlns:a16="http://schemas.microsoft.com/office/drawing/2014/main" id="{E8E2DFE7-BB4F-4FE3-BEF9-9CE0BC199D91}"/>
                    </a:ext>
                  </a:extLst>
                </p:cNvPr>
                <p:cNvGrpSpPr/>
                <p:nvPr/>
              </p:nvGrpSpPr>
              <p:grpSpPr>
                <a:xfrm>
                  <a:off x="663066" y="645799"/>
                  <a:ext cx="5718560" cy="2997229"/>
                  <a:chOff x="0" y="0"/>
                  <a:chExt cx="5718560" cy="2997229"/>
                </a:xfrm>
              </p:grpSpPr>
              <p:grpSp>
                <p:nvGrpSpPr>
                  <p:cNvPr id="31" name="그룹 30">
                    <a:extLst>
                      <a:ext uri="{FF2B5EF4-FFF2-40B4-BE49-F238E27FC236}">
                        <a16:creationId xmlns:a16="http://schemas.microsoft.com/office/drawing/2014/main" id="{CCB6F206-44D6-4C48-8602-9CF796F6F7C2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18560" cy="2997229"/>
                    <a:chOff x="0" y="0"/>
                    <a:chExt cx="6113798" cy="3579573"/>
                  </a:xfrm>
                </p:grpSpPr>
                <p:grpSp>
                  <p:nvGrpSpPr>
                    <p:cNvPr id="33" name="그룹 32">
                      <a:extLst>
                        <a:ext uri="{FF2B5EF4-FFF2-40B4-BE49-F238E27FC236}">
                          <a16:creationId xmlns:a16="http://schemas.microsoft.com/office/drawing/2014/main" id="{5082947D-3572-41F9-9422-BD261F2771C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6113798" cy="3579573"/>
                      <a:chOff x="0" y="0"/>
                      <a:chExt cx="11105321" cy="4138820"/>
                    </a:xfrm>
                  </p:grpSpPr>
                  <p:graphicFrame>
                    <p:nvGraphicFramePr>
                      <p:cNvPr id="35" name="차트 34">
                        <a:extLst>
                          <a:ext uri="{FF2B5EF4-FFF2-40B4-BE49-F238E27FC236}">
                            <a16:creationId xmlns:a16="http://schemas.microsoft.com/office/drawing/2014/main" id="{88F98063-72BF-4C82-AE61-7ED7AAD78981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36" name="차트 35">
                        <a:extLst>
                          <a:ext uri="{FF2B5EF4-FFF2-40B4-BE49-F238E27FC236}">
                            <a16:creationId xmlns:a16="http://schemas.microsoft.com/office/drawing/2014/main" id="{92AABB33-0FDA-4BA3-A0DB-EAC6EE86FDC1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5" y="0"/>
                      <a:ext cx="5831906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34" name="직선 연결선 33">
                      <a:extLst>
                        <a:ext uri="{FF2B5EF4-FFF2-40B4-BE49-F238E27FC236}">
                          <a16:creationId xmlns:a16="http://schemas.microsoft.com/office/drawing/2014/main" id="{C221E091-C21B-4E65-817C-5F0DF13E215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212875" y="2008718"/>
                      <a:ext cx="2001501" cy="1227854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2" name="직선 연결선 31">
                    <a:extLst>
                      <a:ext uri="{FF2B5EF4-FFF2-40B4-BE49-F238E27FC236}">
                        <a16:creationId xmlns:a16="http://schemas.microsoft.com/office/drawing/2014/main" id="{7C65073A-665B-470B-B5E9-A620A2A626D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55166" y="285751"/>
                    <a:ext cx="1839176" cy="1044486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" name="그룹 2">
                <a:extLst>
                  <a:ext uri="{FF2B5EF4-FFF2-40B4-BE49-F238E27FC236}">
                    <a16:creationId xmlns:a16="http://schemas.microsoft.com/office/drawing/2014/main" id="{DE3B59A7-2C70-4553-B35A-109695641CCF}"/>
                  </a:ext>
                </a:extLst>
              </p:cNvPr>
              <p:cNvGrpSpPr/>
              <p:nvPr/>
            </p:nvGrpSpPr>
            <p:grpSpPr>
              <a:xfrm>
                <a:off x="515254" y="3643408"/>
                <a:ext cx="5827492" cy="2923986"/>
                <a:chOff x="515254" y="3643408"/>
                <a:chExt cx="5827492" cy="2923986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58A911A-63B4-40A6-978C-8464EFBD17F1}"/>
                    </a:ext>
                  </a:extLst>
                </p:cNvPr>
                <p:cNvSpPr txBox="1"/>
                <p:nvPr/>
              </p:nvSpPr>
              <p:spPr>
                <a:xfrm>
                  <a:off x="515254" y="3681480"/>
                  <a:ext cx="15696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death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7" name="그룹 36">
                  <a:extLst>
                    <a:ext uri="{FF2B5EF4-FFF2-40B4-BE49-F238E27FC236}">
                      <a16:creationId xmlns:a16="http://schemas.microsoft.com/office/drawing/2014/main" id="{DAEE77BA-3E5B-49B5-B7D5-9A1CD699A35A}"/>
                    </a:ext>
                  </a:extLst>
                </p:cNvPr>
                <p:cNvGrpSpPr/>
                <p:nvPr/>
              </p:nvGrpSpPr>
              <p:grpSpPr>
                <a:xfrm>
                  <a:off x="663066" y="3643408"/>
                  <a:ext cx="5679680" cy="2923986"/>
                  <a:chOff x="0" y="0"/>
                  <a:chExt cx="5717829" cy="3298744"/>
                </a:xfrm>
              </p:grpSpPr>
              <p:grpSp>
                <p:nvGrpSpPr>
                  <p:cNvPr id="38" name="그룹 37">
                    <a:extLst>
                      <a:ext uri="{FF2B5EF4-FFF2-40B4-BE49-F238E27FC236}">
                        <a16:creationId xmlns:a16="http://schemas.microsoft.com/office/drawing/2014/main" id="{F3E3F613-CE55-485E-A467-51057CA65183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17829" cy="3298744"/>
                    <a:chOff x="0" y="0"/>
                    <a:chExt cx="5695116" cy="3251851"/>
                  </a:xfrm>
                </p:grpSpPr>
                <p:grpSp>
                  <p:nvGrpSpPr>
                    <p:cNvPr id="40" name="그룹 39">
                      <a:extLst>
                        <a:ext uri="{FF2B5EF4-FFF2-40B4-BE49-F238E27FC236}">
                          <a16:creationId xmlns:a16="http://schemas.microsoft.com/office/drawing/2014/main" id="{632552AA-137C-453C-8426-D3391224810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695116" cy="3251851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42" name="차트 41">
                        <a:extLst>
                          <a:ext uri="{FF2B5EF4-FFF2-40B4-BE49-F238E27FC236}">
                            <a16:creationId xmlns:a16="http://schemas.microsoft.com/office/drawing/2014/main" id="{8C195EC6-7BF5-4760-9F09-15BB5A7F015D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4"/>
                      </a:graphicData>
                    </a:graphic>
                  </p:graphicFrame>
                  <p:graphicFrame>
                    <p:nvGraphicFramePr>
                      <p:cNvPr id="43" name="차트 42">
                        <a:extLst>
                          <a:ext uri="{FF2B5EF4-FFF2-40B4-BE49-F238E27FC236}">
                            <a16:creationId xmlns:a16="http://schemas.microsoft.com/office/drawing/2014/main" id="{412E9E28-3952-4C99-95F0-C25C6C833540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3" y="0"/>
                      <a:ext cx="5831909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</p:grpSp>
                <p:cxnSp>
                  <p:nvCxnSpPr>
                    <p:cNvPr id="41" name="직선 연결선 40">
                      <a:extLst>
                        <a:ext uri="{FF2B5EF4-FFF2-40B4-BE49-F238E27FC236}">
                          <a16:creationId xmlns:a16="http://schemas.microsoft.com/office/drawing/2014/main" id="{1E73C66E-1640-4A0B-BA59-A60E7F9E967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28680" y="1852289"/>
                      <a:ext cx="1752094" cy="1030081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9" name="직선 연결선 38">
                    <a:extLst>
                      <a:ext uri="{FF2B5EF4-FFF2-40B4-BE49-F238E27FC236}">
                        <a16:creationId xmlns:a16="http://schemas.microsoft.com/office/drawing/2014/main" id="{29472930-393E-47C9-88F4-1E8B0867A38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53141" y="470931"/>
                    <a:ext cx="1623675" cy="1060884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8ADF2325-F460-4A9C-B185-146B3CDB3ECB}"/>
                  </a:ext>
                </a:extLst>
              </p:cNvPr>
              <p:cNvGrpSpPr/>
              <p:nvPr/>
            </p:nvGrpSpPr>
            <p:grpSpPr>
              <a:xfrm>
                <a:off x="515254" y="6536492"/>
                <a:ext cx="5866373" cy="2955816"/>
                <a:chOff x="515254" y="6536492"/>
                <a:chExt cx="5866373" cy="2955816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1CCE139B-33F4-42FE-852F-5255F617D6FF}"/>
                    </a:ext>
                  </a:extLst>
                </p:cNvPr>
                <p:cNvSpPr txBox="1"/>
                <p:nvPr/>
              </p:nvSpPr>
              <p:spPr>
                <a:xfrm>
                  <a:off x="515254" y="6538005"/>
                  <a:ext cx="17187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death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44" name="그룹 43">
                  <a:extLst>
                    <a:ext uri="{FF2B5EF4-FFF2-40B4-BE49-F238E27FC236}">
                      <a16:creationId xmlns:a16="http://schemas.microsoft.com/office/drawing/2014/main" id="{55849A5F-F0DC-4BD8-930B-362DD41C2B49}"/>
                    </a:ext>
                  </a:extLst>
                </p:cNvPr>
                <p:cNvGrpSpPr/>
                <p:nvPr/>
              </p:nvGrpSpPr>
              <p:grpSpPr>
                <a:xfrm>
                  <a:off x="663066" y="6536492"/>
                  <a:ext cx="5718561" cy="2955816"/>
                  <a:chOff x="0" y="0"/>
                  <a:chExt cx="5708367" cy="3214577"/>
                </a:xfrm>
              </p:grpSpPr>
              <p:grpSp>
                <p:nvGrpSpPr>
                  <p:cNvPr id="45" name="그룹 44">
                    <a:extLst>
                      <a:ext uri="{FF2B5EF4-FFF2-40B4-BE49-F238E27FC236}">
                        <a16:creationId xmlns:a16="http://schemas.microsoft.com/office/drawing/2014/main" id="{B273E68F-1C2F-4543-8335-236A581BEC96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7" cy="3214577"/>
                    <a:chOff x="0" y="0"/>
                    <a:chExt cx="11105322" cy="4138820"/>
                  </a:xfrm>
                </p:grpSpPr>
                <p:graphicFrame>
                  <p:nvGraphicFramePr>
                    <p:cNvPr id="51" name="차트 50">
                      <a:extLst>
                        <a:ext uri="{FF2B5EF4-FFF2-40B4-BE49-F238E27FC236}">
                          <a16:creationId xmlns:a16="http://schemas.microsoft.com/office/drawing/2014/main" id="{4AE202A0-D064-4CE5-B05E-4D86FE919BF2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52" name="차트 51">
                      <a:extLst>
                        <a:ext uri="{FF2B5EF4-FFF2-40B4-BE49-F238E27FC236}">
                          <a16:creationId xmlns:a16="http://schemas.microsoft.com/office/drawing/2014/main" id="{2E377610-BDA5-4932-A93B-6B739AFA7D2F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49" name="직선 연결선 48">
                    <a:extLst>
                      <a:ext uri="{FF2B5EF4-FFF2-40B4-BE49-F238E27FC236}">
                        <a16:creationId xmlns:a16="http://schemas.microsoft.com/office/drawing/2014/main" id="{6915ADB8-81CB-41C3-B940-73A7C677D4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80758" y="339090"/>
                    <a:ext cx="1769954" cy="110128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직선 연결선 49">
                    <a:extLst>
                      <a:ext uri="{FF2B5EF4-FFF2-40B4-BE49-F238E27FC236}">
                        <a16:creationId xmlns:a16="http://schemas.microsoft.com/office/drawing/2014/main" id="{0033633A-1971-4D49-85AC-7748298802C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95386" y="1747669"/>
                    <a:ext cx="1784582" cy="1149260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586423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5</TotalTime>
  <Words>85</Words>
  <Application>Microsoft Office PowerPoint</Application>
  <PresentationFormat>A4 용지(210x297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32</cp:revision>
  <dcterms:created xsi:type="dcterms:W3CDTF">2024-07-11T07:58:49Z</dcterms:created>
  <dcterms:modified xsi:type="dcterms:W3CDTF">2025-09-25T00:27:26Z</dcterms:modified>
</cp:coreProperties>
</file>